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0D5DDD2-3CBD-190C-0943-68E9F3DFA4F4}" name="Keri M Kemp" initials="KK" userId="M3PUscox1Q2uQ2fTkBDp9b433opNLysffOQ1yBx1DBs=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A006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8809"/>
    <p:restoredTop sz="89388"/>
  </p:normalViewPr>
  <p:slideViewPr>
    <p:cSldViewPr snapToGrid="0" snapToObjects="1">
      <p:cViewPr varScale="1">
        <p:scale>
          <a:sx n="77" d="100"/>
          <a:sy n="77" d="100"/>
        </p:scale>
        <p:origin x="278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3">
  <dgm:title val=""/>
  <dgm:desc val=""/>
  <dgm:catLst>
    <dgm:cat type="accent1" pri="11300"/>
  </dgm:catLst>
  <dgm:styleLbl name="node0">
    <dgm:fillClrLst meth="repeat">
      <a:schemeClr val="accent1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1">
        <a:shade val="80000"/>
      </a:schemeClr>
      <a:schemeClr val="accent1">
        <a:tint val="7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/>
    <dgm:txEffectClrLst/>
  </dgm:styleLbl>
  <dgm:styleLbl name="node1">
    <dgm:fillClrLst>
      <a:schemeClr val="accent1">
        <a:shade val="80000"/>
      </a:schemeClr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lnNode1">
    <dgm:fillClrLst>
      <a:schemeClr val="accent1">
        <a:shade val="80000"/>
      </a:schemeClr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1">
        <a:shade val="80000"/>
        <a:alpha val="50000"/>
      </a:schemeClr>
      <a:schemeClr val="accent1">
        <a:tint val="7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1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/>
    <dgm:txEffectClrLst/>
  </dgm:styleLbl>
  <dgm:styleLbl name="fgSibTrans2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sibTrans1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1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1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>
        <a:tint val="90000"/>
      </a:schemeClr>
    </dgm:fillClrLst>
    <dgm:linClrLst meth="repeat">
      <a:schemeClr val="accent1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1">
        <a:tint val="70000"/>
      </a:schemeClr>
    </dgm:fillClrLst>
    <dgm:linClrLst meth="repeat">
      <a:schemeClr val="accent1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1">
        <a:tint val="50000"/>
      </a:schemeClr>
    </dgm:fillClrLst>
    <dgm:linClrLst meth="repeat">
      <a:schemeClr val="accent1">
        <a:tint val="50000"/>
      </a:schemeClr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>
        <a:shade val="80000"/>
      </a:schemeClr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>
        <a:tint val="99000"/>
      </a:schemeClr>
    </dgm:fillClrLst>
    <dgm:linClrLst meth="repeat">
      <a:schemeClr val="accent1">
        <a:tint val="99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>
        <a:tint val="80000"/>
      </a:schemeClr>
    </dgm:fillClrLst>
    <dgm:linClrLst meth="repeat">
      <a:schemeClr val="accent1">
        <a:tint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>
        <a:tint val="70000"/>
      </a:schemeClr>
    </dgm:fillClrLst>
    <dgm:linClrLst meth="repeat">
      <a:schemeClr val="accent1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>
        <a:tint val="99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>
        <a:tint val="8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61DE0B63-B6BE-9B41-BC0A-272CD7614D5C}" type="doc">
      <dgm:prSet loTypeId="urn:microsoft.com/office/officeart/2005/8/layout/pyramid1" loCatId="" qsTypeId="urn:microsoft.com/office/officeart/2005/8/quickstyle/simple5" qsCatId="simple" csTypeId="urn:microsoft.com/office/officeart/2005/8/colors/accent1_3" csCatId="accent1" phldr="1"/>
      <dgm:spPr/>
    </dgm:pt>
    <dgm:pt modelId="{511DC0E0-5477-8E40-87FE-ED0E41E6E65B}">
      <dgm:prSet phldrT="[Text]" custT="1"/>
      <dgm:spPr>
        <a:ln>
          <a:solidFill>
            <a:srgbClr val="AA0064"/>
          </a:solidFill>
        </a:ln>
      </dgm:spPr>
      <dgm:t>
        <a:bodyPr/>
        <a:lstStyle/>
        <a:p>
          <a:r>
            <a:rPr lang="en-US" sz="1400" b="1" dirty="0">
              <a:solidFill>
                <a:schemeClr val="bg1"/>
              </a:solidFill>
            </a:rPr>
            <a:t>CVD</a:t>
          </a:r>
        </a:p>
      </dgm:t>
    </dgm:pt>
    <dgm:pt modelId="{2E181C81-7786-F74B-9D11-2B7746E612C1}" type="parTrans" cxnId="{5127139F-79FB-0149-AFCE-B668AC9816F5}">
      <dgm:prSet/>
      <dgm:spPr/>
      <dgm:t>
        <a:bodyPr/>
        <a:lstStyle/>
        <a:p>
          <a:endParaRPr lang="en-US"/>
        </a:p>
      </dgm:t>
    </dgm:pt>
    <dgm:pt modelId="{003A0725-754F-684E-B615-B87547C54473}" type="sibTrans" cxnId="{5127139F-79FB-0149-AFCE-B668AC9816F5}">
      <dgm:prSet/>
      <dgm:spPr/>
      <dgm:t>
        <a:bodyPr/>
        <a:lstStyle/>
        <a:p>
          <a:endParaRPr lang="en-US"/>
        </a:p>
      </dgm:t>
    </dgm:pt>
    <dgm:pt modelId="{2B30A74E-D3A3-7247-94CB-803070B751D2}">
      <dgm:prSet phldrT="[Text]" custT="1"/>
      <dgm:spPr>
        <a:ln>
          <a:solidFill>
            <a:srgbClr val="AA0064"/>
          </a:solidFill>
        </a:ln>
      </dgm:spPr>
      <dgm:t>
        <a:bodyPr/>
        <a:lstStyle/>
        <a:p>
          <a:r>
            <a:rPr lang="en-US" sz="1600" b="1" dirty="0">
              <a:solidFill>
                <a:schemeClr val="bg1"/>
              </a:solidFill>
            </a:rPr>
            <a:t>Hypertension</a:t>
          </a:r>
        </a:p>
        <a:p>
          <a:r>
            <a:rPr lang="en-US" sz="1600" b="1" dirty="0">
              <a:solidFill>
                <a:schemeClr val="bg1"/>
              </a:solidFill>
            </a:rPr>
            <a:t>In adulthood</a:t>
          </a:r>
        </a:p>
      </dgm:t>
    </dgm:pt>
    <dgm:pt modelId="{B60AE52B-C7EA-8045-A683-2C4EA144F72E}" type="parTrans" cxnId="{04E146DA-C4C8-E94B-A7A1-3D43B6CCE45B}">
      <dgm:prSet/>
      <dgm:spPr/>
      <dgm:t>
        <a:bodyPr/>
        <a:lstStyle/>
        <a:p>
          <a:endParaRPr lang="en-US"/>
        </a:p>
      </dgm:t>
    </dgm:pt>
    <dgm:pt modelId="{40D96F3B-86CA-7D48-A438-788FBC5FBE00}" type="sibTrans" cxnId="{04E146DA-C4C8-E94B-A7A1-3D43B6CCE45B}">
      <dgm:prSet/>
      <dgm:spPr/>
      <dgm:t>
        <a:bodyPr/>
        <a:lstStyle/>
        <a:p>
          <a:endParaRPr lang="en-US"/>
        </a:p>
      </dgm:t>
    </dgm:pt>
    <dgm:pt modelId="{CB10DBCA-C610-0041-8DE0-7A48EA945452}">
      <dgm:prSet phldrT="[Text]" custT="1"/>
      <dgm:spPr>
        <a:ln>
          <a:solidFill>
            <a:srgbClr val="AA0064"/>
          </a:solidFill>
        </a:ln>
      </dgm:spPr>
      <dgm:t>
        <a:bodyPr/>
        <a:lstStyle/>
        <a:p>
          <a:r>
            <a:rPr lang="en-US" sz="2000" b="1" dirty="0">
              <a:solidFill>
                <a:schemeClr val="bg1"/>
              </a:solidFill>
            </a:rPr>
            <a:t>Adverse Childhood Experiences (ACEs)</a:t>
          </a:r>
        </a:p>
      </dgm:t>
    </dgm:pt>
    <dgm:pt modelId="{178C9515-B142-844A-A922-0D60C9FB285F}" type="parTrans" cxnId="{EED7F120-F9A1-4841-ABE0-9798939EAAED}">
      <dgm:prSet/>
      <dgm:spPr/>
      <dgm:t>
        <a:bodyPr/>
        <a:lstStyle/>
        <a:p>
          <a:endParaRPr lang="en-US"/>
        </a:p>
      </dgm:t>
    </dgm:pt>
    <dgm:pt modelId="{F07CA92D-7CF0-3840-BBCD-BCCB53BAF6D4}" type="sibTrans" cxnId="{EED7F120-F9A1-4841-ABE0-9798939EAAED}">
      <dgm:prSet/>
      <dgm:spPr/>
      <dgm:t>
        <a:bodyPr/>
        <a:lstStyle/>
        <a:p>
          <a:endParaRPr lang="en-US"/>
        </a:p>
      </dgm:t>
    </dgm:pt>
    <dgm:pt modelId="{84143C6E-312F-1C4C-B345-E21CAFB08CA6}">
      <dgm:prSet custT="1"/>
      <dgm:spPr>
        <a:ln>
          <a:solidFill>
            <a:srgbClr val="AA0064"/>
          </a:solidFill>
        </a:ln>
      </dgm:spPr>
      <dgm:t>
        <a:bodyPr/>
        <a:lstStyle/>
        <a:p>
          <a:r>
            <a:rPr lang="en-US" sz="2000" b="1" dirty="0">
              <a:solidFill>
                <a:schemeClr val="bg1"/>
              </a:solidFill>
            </a:rPr>
            <a:t>Increased AIx in Adolescence</a:t>
          </a:r>
        </a:p>
      </dgm:t>
    </dgm:pt>
    <dgm:pt modelId="{E7B6212D-07C3-6B48-A230-BA2746693F7E}" type="parTrans" cxnId="{4701517F-BAAD-5B41-9E6F-9A965599858C}">
      <dgm:prSet/>
      <dgm:spPr/>
      <dgm:t>
        <a:bodyPr/>
        <a:lstStyle/>
        <a:p>
          <a:endParaRPr lang="en-US"/>
        </a:p>
      </dgm:t>
    </dgm:pt>
    <dgm:pt modelId="{EC3E0F14-4098-594A-8A00-21494016D33B}" type="sibTrans" cxnId="{4701517F-BAAD-5B41-9E6F-9A965599858C}">
      <dgm:prSet/>
      <dgm:spPr/>
      <dgm:t>
        <a:bodyPr/>
        <a:lstStyle/>
        <a:p>
          <a:endParaRPr lang="en-US"/>
        </a:p>
      </dgm:t>
    </dgm:pt>
    <dgm:pt modelId="{BB9A2BBA-8607-D445-A2D9-657A53A0A80B}" type="pres">
      <dgm:prSet presAssocID="{61DE0B63-B6BE-9B41-BC0A-272CD7614D5C}" presName="Name0" presStyleCnt="0">
        <dgm:presLayoutVars>
          <dgm:dir/>
          <dgm:animLvl val="lvl"/>
          <dgm:resizeHandles val="exact"/>
        </dgm:presLayoutVars>
      </dgm:prSet>
      <dgm:spPr/>
    </dgm:pt>
    <dgm:pt modelId="{F837D0CB-762F-0745-8165-14EC3D09F6F0}" type="pres">
      <dgm:prSet presAssocID="{511DC0E0-5477-8E40-87FE-ED0E41E6E65B}" presName="Name8" presStyleCnt="0"/>
      <dgm:spPr/>
    </dgm:pt>
    <dgm:pt modelId="{3525F647-7B0F-7B46-8BF1-459C9E30153B}" type="pres">
      <dgm:prSet presAssocID="{511DC0E0-5477-8E40-87FE-ED0E41E6E65B}" presName="level" presStyleLbl="node1" presStyleIdx="0" presStyleCnt="4" custScaleX="105509" custScaleY="96035">
        <dgm:presLayoutVars>
          <dgm:chMax val="1"/>
          <dgm:bulletEnabled val="1"/>
        </dgm:presLayoutVars>
      </dgm:prSet>
      <dgm:spPr/>
    </dgm:pt>
    <dgm:pt modelId="{9CF0860E-7FA8-794A-85B2-E71D71D2862C}" type="pres">
      <dgm:prSet presAssocID="{511DC0E0-5477-8E40-87FE-ED0E41E6E65B}" presName="levelTx" presStyleLbl="revTx" presStyleIdx="0" presStyleCnt="0">
        <dgm:presLayoutVars>
          <dgm:chMax val="1"/>
          <dgm:bulletEnabled val="1"/>
        </dgm:presLayoutVars>
      </dgm:prSet>
      <dgm:spPr/>
    </dgm:pt>
    <dgm:pt modelId="{2D44EBC8-07D0-1B4D-9FC9-E45808AAD5C8}" type="pres">
      <dgm:prSet presAssocID="{2B30A74E-D3A3-7247-94CB-803070B751D2}" presName="Name8" presStyleCnt="0"/>
      <dgm:spPr/>
    </dgm:pt>
    <dgm:pt modelId="{F4DEB7DF-6845-9D4C-A41D-FBAA3B1095B6}" type="pres">
      <dgm:prSet presAssocID="{2B30A74E-D3A3-7247-94CB-803070B751D2}" presName="level" presStyleLbl="node1" presStyleIdx="1" presStyleCnt="4" custScaleX="102669">
        <dgm:presLayoutVars>
          <dgm:chMax val="1"/>
          <dgm:bulletEnabled val="1"/>
        </dgm:presLayoutVars>
      </dgm:prSet>
      <dgm:spPr/>
    </dgm:pt>
    <dgm:pt modelId="{93D6ECEE-1410-EB4B-9B4A-C823FBB6AB7B}" type="pres">
      <dgm:prSet presAssocID="{2B30A74E-D3A3-7247-94CB-803070B751D2}" presName="levelTx" presStyleLbl="revTx" presStyleIdx="0" presStyleCnt="0">
        <dgm:presLayoutVars>
          <dgm:chMax val="1"/>
          <dgm:bulletEnabled val="1"/>
        </dgm:presLayoutVars>
      </dgm:prSet>
      <dgm:spPr/>
    </dgm:pt>
    <dgm:pt modelId="{90C576B2-31FC-544E-8FDE-52241DB2D13B}" type="pres">
      <dgm:prSet presAssocID="{84143C6E-312F-1C4C-B345-E21CAFB08CA6}" presName="Name8" presStyleCnt="0"/>
      <dgm:spPr/>
    </dgm:pt>
    <dgm:pt modelId="{59BFAFA0-1639-8744-9FC9-F14898483BA9}" type="pres">
      <dgm:prSet presAssocID="{84143C6E-312F-1C4C-B345-E21CAFB08CA6}" presName="level" presStyleLbl="node1" presStyleIdx="2" presStyleCnt="4">
        <dgm:presLayoutVars>
          <dgm:chMax val="1"/>
          <dgm:bulletEnabled val="1"/>
        </dgm:presLayoutVars>
      </dgm:prSet>
      <dgm:spPr/>
    </dgm:pt>
    <dgm:pt modelId="{DC1B9DEC-C990-FF45-8F45-5C965517E5CF}" type="pres">
      <dgm:prSet presAssocID="{84143C6E-312F-1C4C-B345-E21CAFB08CA6}" presName="levelTx" presStyleLbl="revTx" presStyleIdx="0" presStyleCnt="0">
        <dgm:presLayoutVars>
          <dgm:chMax val="1"/>
          <dgm:bulletEnabled val="1"/>
        </dgm:presLayoutVars>
      </dgm:prSet>
      <dgm:spPr/>
    </dgm:pt>
    <dgm:pt modelId="{9181EBE7-BDDF-3149-A72A-19156C042DED}" type="pres">
      <dgm:prSet presAssocID="{CB10DBCA-C610-0041-8DE0-7A48EA945452}" presName="Name8" presStyleCnt="0"/>
      <dgm:spPr/>
    </dgm:pt>
    <dgm:pt modelId="{42B04304-815C-2C4A-A722-DB841A4A5110}" type="pres">
      <dgm:prSet presAssocID="{CB10DBCA-C610-0041-8DE0-7A48EA945452}" presName="level" presStyleLbl="node1" presStyleIdx="3" presStyleCnt="4">
        <dgm:presLayoutVars>
          <dgm:chMax val="1"/>
          <dgm:bulletEnabled val="1"/>
        </dgm:presLayoutVars>
      </dgm:prSet>
      <dgm:spPr/>
    </dgm:pt>
    <dgm:pt modelId="{3A851E6C-7B61-F04D-A653-7D51D061C3A5}" type="pres">
      <dgm:prSet presAssocID="{CB10DBCA-C610-0041-8DE0-7A48EA945452}" presName="levelTx" presStyleLbl="revTx" presStyleIdx="0" presStyleCnt="0">
        <dgm:presLayoutVars>
          <dgm:chMax val="1"/>
          <dgm:bulletEnabled val="1"/>
        </dgm:presLayoutVars>
      </dgm:prSet>
      <dgm:spPr/>
    </dgm:pt>
  </dgm:ptLst>
  <dgm:cxnLst>
    <dgm:cxn modelId="{0E12B40F-2231-BB48-AFCC-9CFAC502DB5F}" type="presOf" srcId="{2B30A74E-D3A3-7247-94CB-803070B751D2}" destId="{F4DEB7DF-6845-9D4C-A41D-FBAA3B1095B6}" srcOrd="0" destOrd="0" presId="urn:microsoft.com/office/officeart/2005/8/layout/pyramid1"/>
    <dgm:cxn modelId="{BC6D7D1D-AE6A-4242-9674-C7641FC5167D}" type="presOf" srcId="{84143C6E-312F-1C4C-B345-E21CAFB08CA6}" destId="{DC1B9DEC-C990-FF45-8F45-5C965517E5CF}" srcOrd="1" destOrd="0" presId="urn:microsoft.com/office/officeart/2005/8/layout/pyramid1"/>
    <dgm:cxn modelId="{EED7F120-F9A1-4841-ABE0-9798939EAAED}" srcId="{61DE0B63-B6BE-9B41-BC0A-272CD7614D5C}" destId="{CB10DBCA-C610-0041-8DE0-7A48EA945452}" srcOrd="3" destOrd="0" parTransId="{178C9515-B142-844A-A922-0D60C9FB285F}" sibTransId="{F07CA92D-7CF0-3840-BBCD-BCCB53BAF6D4}"/>
    <dgm:cxn modelId="{8A8F7959-FD2A-1045-A362-969829464C60}" type="presOf" srcId="{CB10DBCA-C610-0041-8DE0-7A48EA945452}" destId="{42B04304-815C-2C4A-A722-DB841A4A5110}" srcOrd="0" destOrd="0" presId="urn:microsoft.com/office/officeart/2005/8/layout/pyramid1"/>
    <dgm:cxn modelId="{A950B879-615C-AE49-8CBE-B610814E24B2}" type="presOf" srcId="{511DC0E0-5477-8E40-87FE-ED0E41E6E65B}" destId="{9CF0860E-7FA8-794A-85B2-E71D71D2862C}" srcOrd="1" destOrd="0" presId="urn:microsoft.com/office/officeart/2005/8/layout/pyramid1"/>
    <dgm:cxn modelId="{4701517F-BAAD-5B41-9E6F-9A965599858C}" srcId="{61DE0B63-B6BE-9B41-BC0A-272CD7614D5C}" destId="{84143C6E-312F-1C4C-B345-E21CAFB08CA6}" srcOrd="2" destOrd="0" parTransId="{E7B6212D-07C3-6B48-A230-BA2746693F7E}" sibTransId="{EC3E0F14-4098-594A-8A00-21494016D33B}"/>
    <dgm:cxn modelId="{FA879588-46F5-6246-B1B0-EF9E5E5ACE15}" type="presOf" srcId="{61DE0B63-B6BE-9B41-BC0A-272CD7614D5C}" destId="{BB9A2BBA-8607-D445-A2D9-657A53A0A80B}" srcOrd="0" destOrd="0" presId="urn:microsoft.com/office/officeart/2005/8/layout/pyramid1"/>
    <dgm:cxn modelId="{77A61D9C-81D5-854B-85EE-CD0727624E3A}" type="presOf" srcId="{511DC0E0-5477-8E40-87FE-ED0E41E6E65B}" destId="{3525F647-7B0F-7B46-8BF1-459C9E30153B}" srcOrd="0" destOrd="0" presId="urn:microsoft.com/office/officeart/2005/8/layout/pyramid1"/>
    <dgm:cxn modelId="{5127139F-79FB-0149-AFCE-B668AC9816F5}" srcId="{61DE0B63-B6BE-9B41-BC0A-272CD7614D5C}" destId="{511DC0E0-5477-8E40-87FE-ED0E41E6E65B}" srcOrd="0" destOrd="0" parTransId="{2E181C81-7786-F74B-9D11-2B7746E612C1}" sibTransId="{003A0725-754F-684E-B615-B87547C54473}"/>
    <dgm:cxn modelId="{8057ABC4-98B9-824A-ABE3-09F840B4CB2E}" type="presOf" srcId="{84143C6E-312F-1C4C-B345-E21CAFB08CA6}" destId="{59BFAFA0-1639-8744-9FC9-F14898483BA9}" srcOrd="0" destOrd="0" presId="urn:microsoft.com/office/officeart/2005/8/layout/pyramid1"/>
    <dgm:cxn modelId="{04E146DA-C4C8-E94B-A7A1-3D43B6CCE45B}" srcId="{61DE0B63-B6BE-9B41-BC0A-272CD7614D5C}" destId="{2B30A74E-D3A3-7247-94CB-803070B751D2}" srcOrd="1" destOrd="0" parTransId="{B60AE52B-C7EA-8045-A683-2C4EA144F72E}" sibTransId="{40D96F3B-86CA-7D48-A438-788FBC5FBE00}"/>
    <dgm:cxn modelId="{1A0D66F4-0E31-9B48-B32D-9CCCDAC64D19}" type="presOf" srcId="{CB10DBCA-C610-0041-8DE0-7A48EA945452}" destId="{3A851E6C-7B61-F04D-A653-7D51D061C3A5}" srcOrd="1" destOrd="0" presId="urn:microsoft.com/office/officeart/2005/8/layout/pyramid1"/>
    <dgm:cxn modelId="{3EC9CCFF-842C-8244-A585-605114FF6B43}" type="presOf" srcId="{2B30A74E-D3A3-7247-94CB-803070B751D2}" destId="{93D6ECEE-1410-EB4B-9B4A-C823FBB6AB7B}" srcOrd="1" destOrd="0" presId="urn:microsoft.com/office/officeart/2005/8/layout/pyramid1"/>
    <dgm:cxn modelId="{1C35142B-DABC-704E-92D4-A631A48EAE19}" type="presParOf" srcId="{BB9A2BBA-8607-D445-A2D9-657A53A0A80B}" destId="{F837D0CB-762F-0745-8165-14EC3D09F6F0}" srcOrd="0" destOrd="0" presId="urn:microsoft.com/office/officeart/2005/8/layout/pyramid1"/>
    <dgm:cxn modelId="{BF8D70CE-49D3-5F46-8852-69322B45E323}" type="presParOf" srcId="{F837D0CB-762F-0745-8165-14EC3D09F6F0}" destId="{3525F647-7B0F-7B46-8BF1-459C9E30153B}" srcOrd="0" destOrd="0" presId="urn:microsoft.com/office/officeart/2005/8/layout/pyramid1"/>
    <dgm:cxn modelId="{6D93E42C-F269-464C-9451-483386B5C8D3}" type="presParOf" srcId="{F837D0CB-762F-0745-8165-14EC3D09F6F0}" destId="{9CF0860E-7FA8-794A-85B2-E71D71D2862C}" srcOrd="1" destOrd="0" presId="urn:microsoft.com/office/officeart/2005/8/layout/pyramid1"/>
    <dgm:cxn modelId="{C18EEC42-7902-0C4C-B660-797CAE8291E4}" type="presParOf" srcId="{BB9A2BBA-8607-D445-A2D9-657A53A0A80B}" destId="{2D44EBC8-07D0-1B4D-9FC9-E45808AAD5C8}" srcOrd="1" destOrd="0" presId="urn:microsoft.com/office/officeart/2005/8/layout/pyramid1"/>
    <dgm:cxn modelId="{74A2EC42-9823-5E4B-BDFA-8318A3618226}" type="presParOf" srcId="{2D44EBC8-07D0-1B4D-9FC9-E45808AAD5C8}" destId="{F4DEB7DF-6845-9D4C-A41D-FBAA3B1095B6}" srcOrd="0" destOrd="0" presId="urn:microsoft.com/office/officeart/2005/8/layout/pyramid1"/>
    <dgm:cxn modelId="{2C6EC566-4D97-5C4C-BEBB-E3FF8208ED25}" type="presParOf" srcId="{2D44EBC8-07D0-1B4D-9FC9-E45808AAD5C8}" destId="{93D6ECEE-1410-EB4B-9B4A-C823FBB6AB7B}" srcOrd="1" destOrd="0" presId="urn:microsoft.com/office/officeart/2005/8/layout/pyramid1"/>
    <dgm:cxn modelId="{D68B8CE4-F360-0041-B25A-0BCF7A44FA4B}" type="presParOf" srcId="{BB9A2BBA-8607-D445-A2D9-657A53A0A80B}" destId="{90C576B2-31FC-544E-8FDE-52241DB2D13B}" srcOrd="2" destOrd="0" presId="urn:microsoft.com/office/officeart/2005/8/layout/pyramid1"/>
    <dgm:cxn modelId="{8537BA5C-65C0-4346-85D1-7F079F4B4C72}" type="presParOf" srcId="{90C576B2-31FC-544E-8FDE-52241DB2D13B}" destId="{59BFAFA0-1639-8744-9FC9-F14898483BA9}" srcOrd="0" destOrd="0" presId="urn:microsoft.com/office/officeart/2005/8/layout/pyramid1"/>
    <dgm:cxn modelId="{F96AEF36-CC25-4A42-B3DD-E023FC1AF6FC}" type="presParOf" srcId="{90C576B2-31FC-544E-8FDE-52241DB2D13B}" destId="{DC1B9DEC-C990-FF45-8F45-5C965517E5CF}" srcOrd="1" destOrd="0" presId="urn:microsoft.com/office/officeart/2005/8/layout/pyramid1"/>
    <dgm:cxn modelId="{7C940935-D043-D04C-9444-91E327AC73EB}" type="presParOf" srcId="{BB9A2BBA-8607-D445-A2D9-657A53A0A80B}" destId="{9181EBE7-BDDF-3149-A72A-19156C042DED}" srcOrd="3" destOrd="0" presId="urn:microsoft.com/office/officeart/2005/8/layout/pyramid1"/>
    <dgm:cxn modelId="{48C97EBE-52FD-8143-A7E0-6AAC642E13B1}" type="presParOf" srcId="{9181EBE7-BDDF-3149-A72A-19156C042DED}" destId="{42B04304-815C-2C4A-A722-DB841A4A5110}" srcOrd="0" destOrd="0" presId="urn:microsoft.com/office/officeart/2005/8/layout/pyramid1"/>
    <dgm:cxn modelId="{15D1C4BE-134D-9945-AC1C-925B02C22F3C}" type="presParOf" srcId="{9181EBE7-BDDF-3149-A72A-19156C042DED}" destId="{3A851E6C-7B61-F04D-A653-7D51D061C3A5}" srcOrd="1" destOrd="0" presId="urn:microsoft.com/office/officeart/2005/8/layout/pyramid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  <a:ext uri="{C62137D5-CB1D-491B-B009-E17868A290BF}">
      <dgm14:recolorImg xmlns:dgm14="http://schemas.microsoft.com/office/drawing/2010/diagram" val="1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3525F647-7B0F-7B46-8BF1-459C9E30153B}">
      <dsp:nvSpPr>
        <dsp:cNvPr id="0" name=""/>
        <dsp:cNvSpPr/>
      </dsp:nvSpPr>
      <dsp:spPr>
        <a:xfrm>
          <a:off x="1418202" y="0"/>
          <a:ext cx="975199" cy="793727"/>
        </a:xfrm>
        <a:prstGeom prst="trapezoid">
          <a:avLst>
            <a:gd name="adj" fmla="val 58224"/>
          </a:avLst>
        </a:prstGeom>
        <a:gradFill rotWithShape="0">
          <a:gsLst>
            <a:gs pos="0">
              <a:schemeClr val="accent1">
                <a:shade val="80000"/>
                <a:hueOff val="0"/>
                <a:satOff val="0"/>
                <a:lumOff val="0"/>
                <a:alphaOff val="0"/>
                <a:satMod val="103000"/>
                <a:lumMod val="102000"/>
                <a:tint val="94000"/>
              </a:schemeClr>
            </a:gs>
            <a:gs pos="50000">
              <a:schemeClr val="accent1">
                <a:shade val="80000"/>
                <a:hueOff val="0"/>
                <a:satOff val="0"/>
                <a:lumOff val="0"/>
                <a:alphaOff val="0"/>
                <a:satMod val="110000"/>
                <a:lumMod val="100000"/>
                <a:shade val="100000"/>
              </a:schemeClr>
            </a:gs>
            <a:gs pos="100000">
              <a:schemeClr val="accent1">
                <a:shade val="80000"/>
                <a:hueOff val="0"/>
                <a:satOff val="0"/>
                <a:lumOff val="0"/>
                <a:alphaOff val="0"/>
                <a:lumMod val="99000"/>
                <a:satMod val="120000"/>
                <a:shade val="78000"/>
              </a:schemeClr>
            </a:gs>
          </a:gsLst>
          <a:lin ang="5400000" scaled="0"/>
        </a:gradFill>
        <a:ln>
          <a:solidFill>
            <a:srgbClr val="AA0064"/>
          </a:solidFill>
        </a:ln>
        <a:effectLst>
          <a:outerShdw blurRad="57150" dist="19050" dir="5400000" algn="ctr" rotWithShape="0">
            <a:srgbClr val="000000">
              <a:alpha val="63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3">
          <a:scrgbClr r="0" g="0" b="0"/>
        </a:effectRef>
        <a:fontRef idx="minor">
          <a:schemeClr val="lt1"/>
        </a:fontRef>
      </dsp:style>
      <dsp:txBody>
        <a:bodyPr spcFirstLastPara="0" vert="horz" wrap="square" lIns="17780" tIns="17780" rIns="1778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 dirty="0">
              <a:solidFill>
                <a:schemeClr val="bg1"/>
              </a:solidFill>
            </a:rPr>
            <a:t>CVD</a:t>
          </a:r>
        </a:p>
      </dsp:txBody>
      <dsp:txXfrm>
        <a:off x="1418202" y="0"/>
        <a:ext cx="975199" cy="793727"/>
      </dsp:txXfrm>
    </dsp:sp>
    <dsp:sp modelId="{F4DEB7DF-6845-9D4C-A41D-FBAA3B1095B6}">
      <dsp:nvSpPr>
        <dsp:cNvPr id="0" name=""/>
        <dsp:cNvSpPr/>
      </dsp:nvSpPr>
      <dsp:spPr>
        <a:xfrm>
          <a:off x="937262" y="793727"/>
          <a:ext cx="1937078" cy="826498"/>
        </a:xfrm>
        <a:prstGeom prst="trapezoid">
          <a:avLst>
            <a:gd name="adj" fmla="val 58224"/>
          </a:avLst>
        </a:prstGeom>
        <a:gradFill rotWithShape="0">
          <a:gsLst>
            <a:gs pos="0">
              <a:schemeClr val="accent1">
                <a:shade val="80000"/>
                <a:hueOff val="116428"/>
                <a:satOff val="-2085"/>
                <a:lumOff val="8862"/>
                <a:alphaOff val="0"/>
                <a:satMod val="103000"/>
                <a:lumMod val="102000"/>
                <a:tint val="94000"/>
              </a:schemeClr>
            </a:gs>
            <a:gs pos="50000">
              <a:schemeClr val="accent1">
                <a:shade val="80000"/>
                <a:hueOff val="116428"/>
                <a:satOff val="-2085"/>
                <a:lumOff val="8862"/>
                <a:alphaOff val="0"/>
                <a:satMod val="110000"/>
                <a:lumMod val="100000"/>
                <a:shade val="100000"/>
              </a:schemeClr>
            </a:gs>
            <a:gs pos="100000">
              <a:schemeClr val="accent1">
                <a:shade val="80000"/>
                <a:hueOff val="116428"/>
                <a:satOff val="-2085"/>
                <a:lumOff val="8862"/>
                <a:alphaOff val="0"/>
                <a:lumMod val="99000"/>
                <a:satMod val="120000"/>
                <a:shade val="78000"/>
              </a:schemeClr>
            </a:gs>
          </a:gsLst>
          <a:lin ang="5400000" scaled="0"/>
        </a:gradFill>
        <a:ln>
          <a:solidFill>
            <a:srgbClr val="AA0064"/>
          </a:solidFill>
        </a:ln>
        <a:effectLst>
          <a:outerShdw blurRad="57150" dist="19050" dir="5400000" algn="ctr" rotWithShape="0">
            <a:srgbClr val="000000">
              <a:alpha val="63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3">
          <a:scrgbClr r="0" g="0" b="0"/>
        </a:effectRef>
        <a:fontRef idx="minor">
          <a:schemeClr val="lt1"/>
        </a:fontRef>
      </dsp:style>
      <dsp:txBody>
        <a:bodyPr spcFirstLastPara="0" vert="horz" wrap="square" lIns="20320" tIns="20320" rIns="2032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b="1" kern="1200" dirty="0">
              <a:solidFill>
                <a:schemeClr val="bg1"/>
              </a:solidFill>
            </a:rPr>
            <a:t>Hypertension</a:t>
          </a:r>
        </a:p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b="1" kern="1200" dirty="0">
              <a:solidFill>
                <a:schemeClr val="bg1"/>
              </a:solidFill>
            </a:rPr>
            <a:t>In adulthood</a:t>
          </a:r>
        </a:p>
      </dsp:txBody>
      <dsp:txXfrm>
        <a:off x="1276251" y="793727"/>
        <a:ext cx="1259100" cy="826498"/>
      </dsp:txXfrm>
    </dsp:sp>
    <dsp:sp modelId="{59BFAFA0-1639-8744-9FC9-F14898483BA9}">
      <dsp:nvSpPr>
        <dsp:cNvPr id="0" name=""/>
        <dsp:cNvSpPr/>
      </dsp:nvSpPr>
      <dsp:spPr>
        <a:xfrm>
          <a:off x="481220" y="1620226"/>
          <a:ext cx="2849162" cy="826498"/>
        </a:xfrm>
        <a:prstGeom prst="trapezoid">
          <a:avLst>
            <a:gd name="adj" fmla="val 58224"/>
          </a:avLst>
        </a:prstGeom>
        <a:gradFill rotWithShape="0">
          <a:gsLst>
            <a:gs pos="0">
              <a:schemeClr val="accent1">
                <a:shade val="80000"/>
                <a:hueOff val="232855"/>
                <a:satOff val="-4171"/>
                <a:lumOff val="17723"/>
                <a:alphaOff val="0"/>
                <a:satMod val="103000"/>
                <a:lumMod val="102000"/>
                <a:tint val="94000"/>
              </a:schemeClr>
            </a:gs>
            <a:gs pos="50000">
              <a:schemeClr val="accent1">
                <a:shade val="80000"/>
                <a:hueOff val="232855"/>
                <a:satOff val="-4171"/>
                <a:lumOff val="17723"/>
                <a:alphaOff val="0"/>
                <a:satMod val="110000"/>
                <a:lumMod val="100000"/>
                <a:shade val="100000"/>
              </a:schemeClr>
            </a:gs>
            <a:gs pos="100000">
              <a:schemeClr val="accent1">
                <a:shade val="80000"/>
                <a:hueOff val="232855"/>
                <a:satOff val="-4171"/>
                <a:lumOff val="17723"/>
                <a:alphaOff val="0"/>
                <a:lumMod val="99000"/>
                <a:satMod val="120000"/>
                <a:shade val="78000"/>
              </a:schemeClr>
            </a:gs>
          </a:gsLst>
          <a:lin ang="5400000" scaled="0"/>
        </a:gradFill>
        <a:ln>
          <a:solidFill>
            <a:srgbClr val="AA0064"/>
          </a:solidFill>
        </a:ln>
        <a:effectLst>
          <a:outerShdw blurRad="57150" dist="19050" dir="5400000" algn="ctr" rotWithShape="0">
            <a:srgbClr val="000000">
              <a:alpha val="63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3">
          <a:scrgbClr r="0" g="0" b="0"/>
        </a:effectRef>
        <a:fontRef idx="minor">
          <a:schemeClr val="lt1"/>
        </a:fontRef>
      </dsp:style>
      <dsp:txBody>
        <a:bodyPr spcFirstLastPara="0" vert="horz" wrap="square" lIns="25400" tIns="25400" rIns="25400" bIns="2540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b="1" kern="1200" dirty="0">
              <a:solidFill>
                <a:schemeClr val="bg1"/>
              </a:solidFill>
            </a:rPr>
            <a:t>Increased AIx in Adolescence</a:t>
          </a:r>
        </a:p>
      </dsp:txBody>
      <dsp:txXfrm>
        <a:off x="979824" y="1620226"/>
        <a:ext cx="1851955" cy="826498"/>
      </dsp:txXfrm>
    </dsp:sp>
    <dsp:sp modelId="{42B04304-815C-2C4A-A722-DB841A4A5110}">
      <dsp:nvSpPr>
        <dsp:cNvPr id="0" name=""/>
        <dsp:cNvSpPr/>
      </dsp:nvSpPr>
      <dsp:spPr>
        <a:xfrm>
          <a:off x="0" y="2446724"/>
          <a:ext cx="3811604" cy="826498"/>
        </a:xfrm>
        <a:prstGeom prst="trapezoid">
          <a:avLst>
            <a:gd name="adj" fmla="val 58224"/>
          </a:avLst>
        </a:prstGeom>
        <a:gradFill rotWithShape="0">
          <a:gsLst>
            <a:gs pos="0">
              <a:schemeClr val="accent1">
                <a:shade val="80000"/>
                <a:hueOff val="349283"/>
                <a:satOff val="-6256"/>
                <a:lumOff val="26585"/>
                <a:alphaOff val="0"/>
                <a:satMod val="103000"/>
                <a:lumMod val="102000"/>
                <a:tint val="94000"/>
              </a:schemeClr>
            </a:gs>
            <a:gs pos="50000">
              <a:schemeClr val="accent1">
                <a:shade val="80000"/>
                <a:hueOff val="349283"/>
                <a:satOff val="-6256"/>
                <a:lumOff val="26585"/>
                <a:alphaOff val="0"/>
                <a:satMod val="110000"/>
                <a:lumMod val="100000"/>
                <a:shade val="100000"/>
              </a:schemeClr>
            </a:gs>
            <a:gs pos="100000">
              <a:schemeClr val="accent1">
                <a:shade val="80000"/>
                <a:hueOff val="349283"/>
                <a:satOff val="-6256"/>
                <a:lumOff val="26585"/>
                <a:alphaOff val="0"/>
                <a:lumMod val="99000"/>
                <a:satMod val="120000"/>
                <a:shade val="78000"/>
              </a:schemeClr>
            </a:gs>
          </a:gsLst>
          <a:lin ang="5400000" scaled="0"/>
        </a:gradFill>
        <a:ln>
          <a:solidFill>
            <a:srgbClr val="AA0064"/>
          </a:solidFill>
        </a:ln>
        <a:effectLst>
          <a:outerShdw blurRad="57150" dist="19050" dir="5400000" algn="ctr" rotWithShape="0">
            <a:srgbClr val="000000">
              <a:alpha val="63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3">
          <a:scrgbClr r="0" g="0" b="0"/>
        </a:effectRef>
        <a:fontRef idx="minor">
          <a:schemeClr val="lt1"/>
        </a:fontRef>
      </dsp:style>
      <dsp:txBody>
        <a:bodyPr spcFirstLastPara="0" vert="horz" wrap="square" lIns="25400" tIns="25400" rIns="25400" bIns="2540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b="1" kern="1200" dirty="0">
              <a:solidFill>
                <a:schemeClr val="bg1"/>
              </a:solidFill>
            </a:rPr>
            <a:t>Adverse Childhood Experiences (ACEs)</a:t>
          </a:r>
        </a:p>
      </dsp:txBody>
      <dsp:txXfrm>
        <a:off x="667030" y="2446724"/>
        <a:ext cx="2477542" cy="826498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yramid1">
  <dgm:title val=""/>
  <dgm:desc val=""/>
  <dgm:catLst>
    <dgm:cat type="pyramid" pri="1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animLvl val="lvl"/>
      <dgm:resizeHandles val="exact"/>
    </dgm:varLst>
    <dgm:choose name="Name1">
      <dgm:if name="Name2" func="var" arg="dir" op="equ" val="norm">
        <dgm:alg type="pyra">
          <dgm:param type="linDir" val="fromB"/>
          <dgm:param type="txDir" val="fromT"/>
          <dgm:param type="pyraAcctPos" val="aft"/>
          <dgm:param type="pyraAcctTxMar" val="step"/>
          <dgm:param type="pyraAcctBkgdNode" val="acctBkgd"/>
          <dgm:param type="pyraAcctTxNode" val="acctTx"/>
          <dgm:param type="pyraLvlNode" val="level"/>
        </dgm:alg>
      </dgm:if>
      <dgm:else name="Name3">
        <dgm:alg type="pyra">
          <dgm:param type="linDir" val="fromB"/>
          <dgm:param type="txDir" val="fromT"/>
          <dgm:param type="pyraAcctPos" val="bef"/>
          <dgm:param type="pyraAcctTxMar" val="step"/>
          <dgm:param type="pyraAcctBkgdNode" val="acctBkgd"/>
          <dgm:param type="pyraAcctTxNode" val="acctTx"/>
          <dgm:param type="pyraLvlNode" val="level"/>
        </dgm:alg>
      </dgm:else>
    </dgm:choose>
    <dgm:shape xmlns:r="http://schemas.openxmlformats.org/officeDocument/2006/relationships" r:blip="">
      <dgm:adjLst/>
    </dgm:shape>
    <dgm:presOf/>
    <dgm:choose name="Name4">
      <dgm:if name="Name5" axis="root des" ptType="all node" func="maxDepth" op="gte" val="2">
        <dgm:constrLst>
          <dgm:constr type="primFontSz" for="des" forName="levelTx" op="equ"/>
          <dgm:constr type="secFontSz" for="des" forName="acctTx" op="equ"/>
          <dgm:constr type="pyraAcctRatio" val="0.32"/>
        </dgm:constrLst>
      </dgm:if>
      <dgm:else name="Name6">
        <dgm:constrLst>
          <dgm:constr type="primFontSz" for="des" forName="levelTx" op="equ"/>
          <dgm:constr type="secFontSz" for="des" forName="acctTx" op="equ"/>
          <dgm:constr type="pyraAcctRatio"/>
        </dgm:constrLst>
      </dgm:else>
    </dgm:choose>
    <dgm:ruleLst/>
    <dgm:forEach name="Name7" axis="ch" ptType="node">
      <dgm:layoutNode name="Name8">
        <dgm:alg type="composite">
          <dgm:param type="horzAlign" val="none"/>
        </dgm:alg>
        <dgm:shape xmlns:r="http://schemas.openxmlformats.org/officeDocument/2006/relationships" r:blip="">
          <dgm:adjLst/>
        </dgm:shape>
        <dgm:presOf/>
        <dgm:choose name="Name9">
          <dgm:if name="Name10" axis="self" ptType="node" func="pos" op="equ" val="1">
            <dgm:constrLst>
              <dgm:constr type="ctrX" for="ch" forName="acctBkgd" val="1"/>
              <dgm:constr type="ctrY" for="ch" forName="acctBkgd" val="1"/>
              <dgm:constr type="w" for="ch" forName="acctBkgd" val="1"/>
              <dgm:constr type="h" for="ch" forName="acctBkgd" val="1"/>
              <dgm:constr type="ctrX" for="ch" forName="acctTx" val="1"/>
              <dgm:constr type="ctrY" for="ch" forName="acctTx" val="1"/>
              <dgm:constr type="w" for="ch" forName="acctTx" val="1"/>
              <dgm:constr type="h" for="ch" forName="acctTx" val="1"/>
              <dgm:constr type="ctrX" for="ch" forName="level" val="1"/>
              <dgm:constr type="ctrY" for="ch" forName="level" val="1"/>
              <dgm:constr type="w" for="ch" forName="level" val="1"/>
              <dgm:constr type="h" for="ch" forName="level" val="1"/>
              <dgm:constr type="ctrX" for="ch" forName="levelTx" refType="ctrX" refFor="ch" refForName="level"/>
              <dgm:constr type="ctrY" for="ch" forName="levelTx" refType="ctrY" refFor="ch" refForName="level"/>
              <dgm:constr type="w" for="ch" forName="levelTx" refType="w" refFor="ch" refForName="level"/>
              <dgm:constr type="h" for="ch" forName="levelTx" refType="h" refFor="ch" refForName="level"/>
            </dgm:constrLst>
          </dgm:if>
          <dgm:else name="Name11">
            <dgm:constrLst>
              <dgm:constr type="ctrX" for="ch" forName="acctBkgd" val="1"/>
              <dgm:constr type="ctrY" for="ch" forName="acctBkgd" val="1"/>
              <dgm:constr type="w" for="ch" forName="acctBkgd" val="1"/>
              <dgm:constr type="h" for="ch" forName="acctBkgd" val="1"/>
              <dgm:constr type="ctrX" for="ch" forName="acctTx" val="1"/>
              <dgm:constr type="ctrY" for="ch" forName="acctTx" val="1"/>
              <dgm:constr type="w" for="ch" forName="acctTx" val="1"/>
              <dgm:constr type="h" for="ch" forName="acctTx" val="1"/>
              <dgm:constr type="ctrX" for="ch" forName="level" val="1"/>
              <dgm:constr type="ctrY" for="ch" forName="level" val="1"/>
              <dgm:constr type="w" for="ch" forName="level" val="1"/>
              <dgm:constr type="h" for="ch" forName="level" val="1"/>
              <dgm:constr type="ctrX" for="ch" forName="levelTx" refType="ctrX" refFor="ch" refForName="level"/>
              <dgm:constr type="ctrY" for="ch" forName="levelTx" refType="ctrY" refFor="ch" refForName="level"/>
              <dgm:constr type="w" for="ch" forName="levelTx" refType="w" refFor="ch" refForName="level" fact="0.65"/>
              <dgm:constr type="h" for="ch" forName="levelTx" refType="h" refFor="ch" refForName="level"/>
            </dgm:constrLst>
          </dgm:else>
        </dgm:choose>
        <dgm:ruleLst/>
        <dgm:choose name="Name12">
          <dgm:if name="Name13" axis="ch" ptType="node" func="cnt" op="gte" val="1">
            <dgm:layoutNode name="acctBkgd" styleLbl="alignAcc1">
              <dgm:alg type="sp"/>
              <dgm:shape xmlns:r="http://schemas.openxmlformats.org/officeDocument/2006/relationships" type="nonIsoscelesTrapezoid" r:blip="">
                <dgm:adjLst/>
              </dgm:shape>
              <dgm:presOf axis="des" ptType="node"/>
              <dgm:constrLst/>
              <dgm:ruleLst/>
            </dgm:layoutNode>
            <dgm:layoutNode name="acctTx" styleLbl="alignAcc1">
              <dgm:varLst>
                <dgm:bulletEnabled val="1"/>
              </dgm:varLst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type="nonIsoscelesTrapezoid" r:blip="" hideGeom="1">
                <dgm:adjLst/>
              </dgm:shape>
              <dgm:presOf axis="des" ptType="node"/>
              <dgm:constrLst>
                <dgm:constr type="secFontSz" val="65"/>
                <dgm:constr type="primFontSz" refType="secFontSz"/>
                <dgm:constr type="tMarg" refType="secFontSz" fact="0.3"/>
                <dgm:constr type="bMarg" refType="secFontSz" fact="0.3"/>
                <dgm:constr type="lMarg" refType="secFontSz" fact="0.3"/>
                <dgm:constr type="rMarg" refType="secFontSz" fact="0.3"/>
              </dgm:constrLst>
              <dgm:ruleLst>
                <dgm:rule type="secFontSz" val="5" fact="NaN" max="NaN"/>
              </dgm:ruleLst>
            </dgm:layoutNode>
          </dgm:if>
          <dgm:else name="Name14"/>
        </dgm:choose>
        <dgm:layoutNode name="level">
          <dgm:varLst>
            <dgm:chMax val="1"/>
            <dgm:bulletEnabled val="1"/>
          </dgm:varLst>
          <dgm:alg type="sp"/>
          <dgm:shape xmlns:r="http://schemas.openxmlformats.org/officeDocument/2006/relationships" type="trapezoid" r:blip="">
            <dgm:adjLst/>
          </dgm:shape>
          <dgm:presOf axis="self"/>
          <dgm:constrLst>
            <dgm:constr type="h" val="500"/>
            <dgm:constr type="w" val="1"/>
          </dgm:constrLst>
          <dgm:ruleLst/>
        </dgm:layoutNode>
        <dgm:layoutNode name="levelTx" styleLbl="revTx">
          <dgm:varLst>
            <dgm:chMax val="1"/>
            <dgm:bulletEnabled val="1"/>
          </dgm:varLst>
          <dgm:alg type="tx"/>
          <dgm:shape xmlns:r="http://schemas.openxmlformats.org/officeDocument/2006/relationships" type="rect" r:blip="" hideGeom="1">
            <dgm:adjLst/>
          </dgm:shape>
          <dgm:presOf axis="self"/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  <dgm:constr type="primFontSz" val="65"/>
          </dgm:constrLst>
          <dgm:ruleLst>
            <dgm:rule type="primFontSz" val="5" fact="NaN" max="NaN"/>
          </dgm:ruleLst>
        </dgm:layoutNode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5">
  <dgm:title val=""/>
  <dgm:desc val=""/>
  <dgm:catLst>
    <dgm:cat type="simple" pri="105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B379B2-C68A-7549-AD19-F6E58B210052}" type="datetimeFigureOut">
              <a:rPr lang="en-US" smtClean="0"/>
              <a:t>12/8/2022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AA4806-BB1A-2741-8DC7-94439D41F97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6830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AA4806-BB1A-2741-8DC7-94439D41F977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386385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AA6FCA-60AB-1549-95A3-792C20CB988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6068911-D4DF-A14F-869A-403EC5291B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DEEB8F-EEA6-7644-8B47-6BF1EAD7F7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5FB21-9EB7-1243-8B01-4D754F38AD59}" type="datetimeFigureOut">
              <a:rPr lang="en-US" smtClean="0"/>
              <a:t>12/8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3C6903-667D-AE45-9D3F-5272C1DA32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CDA1D0-E067-B540-BAB3-8A754B1FC9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61C43-C4F5-5443-85F2-6F8AFA9FCEB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333154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035715-54BB-7A4E-A558-26D372A9F9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02B5694-62EB-014A-9060-EF41BC44C3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723A9B-FE32-B54D-8BFA-40205DBECE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5FB21-9EB7-1243-8B01-4D754F38AD59}" type="datetimeFigureOut">
              <a:rPr lang="en-US" smtClean="0"/>
              <a:t>12/8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C76E93-2367-C148-9F0D-B87E3603C9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1C5BA6-84A3-8F4C-A06F-DFE4FF25FD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61C43-C4F5-5443-85F2-6F8AFA9FCEB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16724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C4DB231-5C6B-BA4B-99A7-7B2E20762D3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B438002-7BFC-994D-ACDB-F3E97235B8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1D16F3-FC6F-5F42-B541-BF2B81923B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5FB21-9EB7-1243-8B01-4D754F38AD59}" type="datetimeFigureOut">
              <a:rPr lang="en-US" smtClean="0"/>
              <a:t>12/8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DDB0A6-5BF3-0F46-8483-F6E8B6B1AE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97DBEC-CB11-3149-9626-7E8AD7BE97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61C43-C4F5-5443-85F2-6F8AFA9FCEB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9196452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17968039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46E35C-B53F-B04F-BE6E-655B6C55AF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08FA36-F6EA-984C-9330-ADF6F796E2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AB0C1D-57F5-084D-BF34-78E1741178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5FB21-9EB7-1243-8B01-4D754F38AD59}" type="datetimeFigureOut">
              <a:rPr lang="en-US" smtClean="0"/>
              <a:t>12/8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4E0567-52F0-B341-9D4E-4CFC18DDCF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C74202-9DED-6348-AA85-CA15599AA8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61C43-C4F5-5443-85F2-6F8AFA9FCEB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229132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961C9D-CAF9-6740-859F-8452765272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281B0F-5072-ED42-8ED8-E0B03796FE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CFC4E6-E3E3-9F4B-A011-071987D3BE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5FB21-9EB7-1243-8B01-4D754F38AD59}" type="datetimeFigureOut">
              <a:rPr lang="en-US" smtClean="0"/>
              <a:t>12/8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A75356-5200-6248-8783-3F55397916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2FEE88-E57C-7440-B867-23DA6A2795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61C43-C4F5-5443-85F2-6F8AFA9FCEB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63341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A3F153-CF39-B844-9727-A5CB7AA146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860439-6BBF-E04B-A3F2-F8B23F0A7A7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DA5BAE8-4507-D24A-B7BF-15722FCE26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A0E6AC-6164-E24B-89A4-E666EC9AF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5FB21-9EB7-1243-8B01-4D754F38AD59}" type="datetimeFigureOut">
              <a:rPr lang="en-US" smtClean="0"/>
              <a:t>12/8/20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942380-7A87-DB43-A24C-2178E40F36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8B20C1-9ABF-8A44-9731-9BD487E305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61C43-C4F5-5443-85F2-6F8AFA9FCEB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74862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FE194D-884C-204A-926E-DEE4C75358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EB10BF-6101-9D4E-9478-AB110B3A30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801E83-D095-1541-B44B-08CFFED1C9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15B5CB7-BDC1-9A4F-8374-8D7750B5F0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EC4B493-FFB1-074F-AB79-836A4EE7BD8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9BB7719-357D-F743-9AE1-7B4D2ADDDA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5FB21-9EB7-1243-8B01-4D754F38AD59}" type="datetimeFigureOut">
              <a:rPr lang="en-US" smtClean="0"/>
              <a:t>12/8/2022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0B2EDA6-FF6F-6044-A1B5-828C5EF0E5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AF70C02-6C61-3F49-AA8D-404F0CBE24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61C43-C4F5-5443-85F2-6F8AFA9FCEB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7372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1E5D96-CAD3-D74A-A125-36CA60E796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E7033FC-FAE9-B54A-A70E-64599114E1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5FB21-9EB7-1243-8B01-4D754F38AD59}" type="datetimeFigureOut">
              <a:rPr lang="en-US" smtClean="0"/>
              <a:t>12/8/2022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0A59C1C-8717-CA42-AEB9-C9AA234264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5608D5D-B2D2-E84F-BDD4-2C23DE6362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61C43-C4F5-5443-85F2-6F8AFA9FCEB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64821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3B166C5-D421-714C-8A9F-21EFCEAF57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5FB21-9EB7-1243-8B01-4D754F38AD59}" type="datetimeFigureOut">
              <a:rPr lang="en-US" smtClean="0"/>
              <a:t>12/8/2022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3A0E418-4176-8B4C-9D2B-6FCB116026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62C4BFF-1106-8548-A00E-3E6BE8A339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61C43-C4F5-5443-85F2-6F8AFA9FCEB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31069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57E291-AF5B-D149-9973-A59A68BB93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901FAF-E578-1B43-A15B-AC0FBBF754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37D461-B6F6-F844-8349-B114FD00F6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30BEE7-485C-1645-BA5E-473140DF98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5FB21-9EB7-1243-8B01-4D754F38AD59}" type="datetimeFigureOut">
              <a:rPr lang="en-US" smtClean="0"/>
              <a:t>12/8/20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FF1D80-807D-FC4E-B3C4-E5B7DC3ED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9B6076-D14E-8949-B7BB-36718C7847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61C43-C4F5-5443-85F2-6F8AFA9FCEB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109028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86E115-97A0-2E4F-B97A-6F6B1E7B14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547822F-AFF8-4648-9516-6BC775A548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1168AAD-2E66-DF41-AE12-23D6BFA063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AD6505-6D56-2546-AA07-8683B2590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5FB21-9EB7-1243-8B01-4D754F38AD59}" type="datetimeFigureOut">
              <a:rPr lang="en-US" smtClean="0"/>
              <a:t>12/8/20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68A03A-FD3C-BB41-9A5C-AED964A63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01B35B-0E3B-FB45-A608-E07B2C4577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61C43-C4F5-5443-85F2-6F8AFA9FCEB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0100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8F4B648-16F7-BE49-BFBC-23B8092EAC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56BB97-62E6-D742-914D-614DA59792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642F72-8FA3-BC4C-AD41-66971C92EC5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B5FB21-9EB7-1243-8B01-4D754F38AD59}" type="datetimeFigureOut">
              <a:rPr lang="en-US" smtClean="0"/>
              <a:t>12/8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9D53BC-7E95-B14D-B08C-25E6285128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1BCF90-79FE-7146-A552-37A9D10ACB6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A61C43-C4F5-5443-85F2-6F8AFA9FCEB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807383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Relationship Id="rId9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61518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400" b="1" dirty="0">
                <a:solidFill>
                  <a:schemeClr val="bg1"/>
                </a:solidFill>
              </a:rPr>
              <a:t>Adverse childhood experiences are associated with vascular changes in adolescents that are risk factors for future cardiovascular disease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42949"/>
            <a:ext cx="11838369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dirty="0">
                <a:solidFill>
                  <a:schemeClr val="bg1"/>
                </a:solidFill>
                <a:ea typeface="+mn-lt"/>
                <a:cs typeface="+mn-lt"/>
              </a:rPr>
              <a:t>ACEs are associated with higher BP and aortic augmentation index (AIx75) during adolescence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Kellum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7" y="5725981"/>
            <a:ext cx="7141846" cy="120032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ACEs are associated with higher AIx75, a surrogate for peripheral arterial stiffening and future CVD in adolescence, but not PWV. Early interventions using Alx75 can target ACE-sensitive pathways contributing to CVD and adverse outcomes in later life. 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0EA98C3-45E1-8B4C-AC73-2D3745B4EA56}"/>
              </a:ext>
            </a:extLst>
          </p:cNvPr>
          <p:cNvSpPr txBox="1"/>
          <p:nvPr/>
        </p:nvSpPr>
        <p:spPr>
          <a:xfrm>
            <a:off x="44197" y="4065233"/>
            <a:ext cx="3021485" cy="132343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Adolescents (11- 18 yrs)</a:t>
            </a:r>
          </a:p>
          <a:p>
            <a:pPr algn="ctr"/>
            <a:r>
              <a:rPr lang="en-GB" sz="2000" dirty="0">
                <a:solidFill>
                  <a:srgbClr val="296DC0"/>
                </a:solidFill>
              </a:rPr>
              <a:t>with or without Adverse Childhood Experiences (ACEs) 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1C3AC09-CD7D-4946-97ED-2D0FE97F34B0}"/>
              </a:ext>
            </a:extLst>
          </p:cNvPr>
          <p:cNvSpPr txBox="1"/>
          <p:nvPr/>
        </p:nvSpPr>
        <p:spPr>
          <a:xfrm>
            <a:off x="-259273" y="2102652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ESTaBLISH Cohort 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588D9FF6-89D6-C44D-8A0F-D7C00CBD49C5}"/>
              </a:ext>
            </a:extLst>
          </p:cNvPr>
          <p:cNvSpPr/>
          <p:nvPr/>
        </p:nvSpPr>
        <p:spPr>
          <a:xfrm>
            <a:off x="173447" y="2102652"/>
            <a:ext cx="2927561" cy="3306668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00437A"/>
              </a:solidFill>
            </a:endParaRP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7097EBB0-446C-244F-8C20-6DB98037300C}"/>
              </a:ext>
            </a:extLst>
          </p:cNvPr>
          <p:cNvCxnSpPr/>
          <p:nvPr/>
        </p:nvCxnSpPr>
        <p:spPr>
          <a:xfrm flipV="1">
            <a:off x="3402811" y="3755986"/>
            <a:ext cx="715833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Rectangle 29">
            <a:extLst>
              <a:ext uri="{FF2B5EF4-FFF2-40B4-BE49-F238E27FC236}">
                <a16:creationId xmlns:a16="http://schemas.microsoft.com/office/drawing/2014/main" id="{CC2B95FD-66DA-5449-89C6-B63ED849114F}"/>
              </a:ext>
            </a:extLst>
          </p:cNvPr>
          <p:cNvSpPr/>
          <p:nvPr/>
        </p:nvSpPr>
        <p:spPr>
          <a:xfrm>
            <a:off x="216916" y="3382053"/>
            <a:ext cx="1320626" cy="662532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en-GB" dirty="0"/>
              <a:t>n=27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CF1262DE-AC19-384B-BCC1-9EFDD3AB006C}"/>
              </a:ext>
            </a:extLst>
          </p:cNvPr>
          <p:cNvSpPr/>
          <p:nvPr/>
        </p:nvSpPr>
        <p:spPr>
          <a:xfrm>
            <a:off x="1705533" y="3382052"/>
            <a:ext cx="1320626" cy="662532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en-GB" dirty="0"/>
              <a:t>n=51</a:t>
            </a:r>
          </a:p>
        </p:txBody>
      </p:sp>
      <p:sp>
        <p:nvSpPr>
          <p:cNvPr id="38" name="Up Arrow 37">
            <a:extLst>
              <a:ext uri="{FF2B5EF4-FFF2-40B4-BE49-F238E27FC236}">
                <a16:creationId xmlns:a16="http://schemas.microsoft.com/office/drawing/2014/main" id="{2B2A14DC-D5E9-3447-A0D1-D5A0D6500EDE}"/>
              </a:ext>
            </a:extLst>
          </p:cNvPr>
          <p:cNvSpPr/>
          <p:nvPr/>
        </p:nvSpPr>
        <p:spPr>
          <a:xfrm rot="10800000" flipH="1" flipV="1">
            <a:off x="6537189" y="3204247"/>
            <a:ext cx="295090" cy="37966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0" name="Up Arrow 39">
            <a:extLst>
              <a:ext uri="{FF2B5EF4-FFF2-40B4-BE49-F238E27FC236}">
                <a16:creationId xmlns:a16="http://schemas.microsoft.com/office/drawing/2014/main" id="{E07D4C6A-BE12-4048-8D3E-FC616BC89BD8}"/>
              </a:ext>
            </a:extLst>
          </p:cNvPr>
          <p:cNvSpPr/>
          <p:nvPr/>
        </p:nvSpPr>
        <p:spPr>
          <a:xfrm rot="16200000" flipH="1" flipV="1">
            <a:off x="6563813" y="2667474"/>
            <a:ext cx="295090" cy="379666"/>
          </a:xfrm>
          <a:prstGeom prst="upArrow">
            <a:avLst>
              <a:gd name="adj1" fmla="val 0"/>
              <a:gd name="adj2" fmla="val 104924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aphicFrame>
        <p:nvGraphicFramePr>
          <p:cNvPr id="51" name="Diagram 50">
            <a:extLst>
              <a:ext uri="{FF2B5EF4-FFF2-40B4-BE49-F238E27FC236}">
                <a16:creationId xmlns:a16="http://schemas.microsoft.com/office/drawing/2014/main" id="{31E51720-3534-D840-9F3F-C46B489799C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884094292"/>
              </p:ext>
            </p:extLst>
          </p:nvPr>
        </p:nvGraphicFramePr>
        <p:xfrm>
          <a:off x="8278173" y="1945931"/>
          <a:ext cx="3811604" cy="327322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5DA5EA79-02E7-C545-BB28-FDBA453E3434}"/>
              </a:ext>
            </a:extLst>
          </p:cNvPr>
          <p:cNvCxnSpPr/>
          <p:nvPr/>
        </p:nvCxnSpPr>
        <p:spPr>
          <a:xfrm flipV="1">
            <a:off x="6312818" y="3753751"/>
            <a:ext cx="715833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Rectangle 4">
            <a:extLst>
              <a:ext uri="{FF2B5EF4-FFF2-40B4-BE49-F238E27FC236}">
                <a16:creationId xmlns:a16="http://schemas.microsoft.com/office/drawing/2014/main" id="{57A5A925-2ED0-724A-B2C6-15F6DC0A0A25}"/>
              </a:ext>
            </a:extLst>
          </p:cNvPr>
          <p:cNvSpPr/>
          <p:nvPr/>
        </p:nvSpPr>
        <p:spPr>
          <a:xfrm>
            <a:off x="0" y="1674120"/>
            <a:ext cx="24048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  <a:endParaRPr lang="en-US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6FD6CC7-9278-744C-B4B3-F5F5653E07B1}"/>
              </a:ext>
            </a:extLst>
          </p:cNvPr>
          <p:cNvSpPr txBox="1"/>
          <p:nvPr/>
        </p:nvSpPr>
        <p:spPr>
          <a:xfrm>
            <a:off x="6906736" y="3135778"/>
            <a:ext cx="2394567" cy="586443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>
              <a:lnSpc>
                <a:spcPts val="1900"/>
              </a:lnSpc>
            </a:pPr>
            <a:r>
              <a:rPr lang="en-GB" sz="2000" b="1" dirty="0">
                <a:solidFill>
                  <a:srgbClr val="AA0065"/>
                </a:solidFill>
              </a:rPr>
              <a:t>Increased AIx75 during adolescence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CDD424B6-956D-E741-A27C-3ACD2A427C1D}"/>
              </a:ext>
            </a:extLst>
          </p:cNvPr>
          <p:cNvSpPr/>
          <p:nvPr/>
        </p:nvSpPr>
        <p:spPr>
          <a:xfrm>
            <a:off x="4389799" y="3482274"/>
            <a:ext cx="1735313" cy="2061129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horz" lIns="91440" tIns="45720" rIns="91440" bIns="45720" rtlCol="0" anchor="b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Aortic augmentation index (AIx75), Pulse Wave Velocity (PWV)</a:t>
            </a: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A4B1F870-63BC-5946-A873-F75FE888FE0D}"/>
              </a:ext>
            </a:extLst>
          </p:cNvPr>
          <p:cNvSpPr/>
          <p:nvPr/>
        </p:nvSpPr>
        <p:spPr>
          <a:xfrm>
            <a:off x="4379073" y="1719733"/>
            <a:ext cx="1735313" cy="1644256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Ambulatory Blood Pressure (BP)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8B886BC7-34A1-0944-AC61-1BDAAC87B351}"/>
              </a:ext>
            </a:extLst>
          </p:cNvPr>
          <p:cNvSpPr txBox="1"/>
          <p:nvPr/>
        </p:nvSpPr>
        <p:spPr>
          <a:xfrm>
            <a:off x="6123255" y="1710176"/>
            <a:ext cx="26653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b="1" dirty="0"/>
              <a:t>ACE exposure: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8DDD3B62-CBDC-E745-AB17-845F8090E36B}"/>
              </a:ext>
            </a:extLst>
          </p:cNvPr>
          <p:cNvSpPr txBox="1"/>
          <p:nvPr/>
        </p:nvSpPr>
        <p:spPr>
          <a:xfrm>
            <a:off x="6936646" y="2657262"/>
            <a:ext cx="2382991" cy="586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900"/>
              </a:lnSpc>
            </a:pPr>
            <a:r>
              <a:rPr lang="en-GB" sz="2000" b="1" dirty="0">
                <a:solidFill>
                  <a:srgbClr val="AA0065"/>
                </a:solidFill>
              </a:rPr>
              <a:t>No changes to PWV during adolescence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9C64E803-3319-204D-854D-4DC7FE7BC8E3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6254" t="27455" r="51676" b="60201"/>
          <a:stretch/>
        </p:blipFill>
        <p:spPr>
          <a:xfrm>
            <a:off x="4557887" y="1745323"/>
            <a:ext cx="1398095" cy="757439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76FFB61E-7941-CE49-9714-092327D3C3C0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396" t="35672" r="87606" b="51310"/>
          <a:stretch/>
        </p:blipFill>
        <p:spPr>
          <a:xfrm>
            <a:off x="312793" y="2454240"/>
            <a:ext cx="1242146" cy="909749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F3717CAA-E3F3-A140-917C-110C1D596712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396" t="35672" r="87606" b="51310"/>
          <a:stretch/>
        </p:blipFill>
        <p:spPr>
          <a:xfrm>
            <a:off x="1737486" y="2454240"/>
            <a:ext cx="1242146" cy="909749"/>
          </a:xfrm>
          <a:prstGeom prst="rect">
            <a:avLst/>
          </a:prstGeom>
        </p:spPr>
      </p:pic>
      <p:sp>
        <p:nvSpPr>
          <p:cNvPr id="26" name="Up Arrow 25">
            <a:extLst>
              <a:ext uri="{FF2B5EF4-FFF2-40B4-BE49-F238E27FC236}">
                <a16:creationId xmlns:a16="http://schemas.microsoft.com/office/drawing/2014/main" id="{C8E43C30-C2DE-2543-87A8-F095E8275E19}"/>
              </a:ext>
            </a:extLst>
          </p:cNvPr>
          <p:cNvSpPr/>
          <p:nvPr/>
        </p:nvSpPr>
        <p:spPr>
          <a:xfrm rot="16200000" flipH="1" flipV="1">
            <a:off x="6559458" y="2146684"/>
            <a:ext cx="295090" cy="379666"/>
          </a:xfrm>
          <a:prstGeom prst="upArrow">
            <a:avLst>
              <a:gd name="adj1" fmla="val 0"/>
              <a:gd name="adj2" fmla="val 104924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C1E5BD6-FC99-8345-BC3C-D5BF2FA390CB}"/>
              </a:ext>
            </a:extLst>
          </p:cNvPr>
          <p:cNvSpPr txBox="1"/>
          <p:nvPr/>
        </p:nvSpPr>
        <p:spPr>
          <a:xfrm>
            <a:off x="6884092" y="2124042"/>
            <a:ext cx="2409082" cy="586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900"/>
              </a:lnSpc>
            </a:pPr>
            <a:r>
              <a:rPr lang="en-GB" sz="2000" b="1" dirty="0">
                <a:solidFill>
                  <a:srgbClr val="AA0065"/>
                </a:solidFill>
              </a:rPr>
              <a:t>No changes to BP during adolescence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B3CEECD-44BB-C247-B730-EA68F247E6C6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36532" b="36426"/>
          <a:stretch/>
        </p:blipFill>
        <p:spPr>
          <a:xfrm>
            <a:off x="4720498" y="3560625"/>
            <a:ext cx="1011378" cy="5692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386916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Graphic spid="51" grpId="0">
        <p:bldAsOne/>
      </p:bldGraphic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142</TotalTime>
  <Words>165</Words>
  <Application>Microsoft Office PowerPoint</Application>
  <PresentationFormat>Widescreen</PresentationFormat>
  <Paragraphs>2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llum, Cailin Elizabeth</dc:creator>
  <cp:lastModifiedBy>Bob Thompson</cp:lastModifiedBy>
  <cp:revision>185</cp:revision>
  <dcterms:created xsi:type="dcterms:W3CDTF">2021-04-16T14:55:33Z</dcterms:created>
  <dcterms:modified xsi:type="dcterms:W3CDTF">2022-12-08T22:58:01Z</dcterms:modified>
</cp:coreProperties>
</file>